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  <p:sldId id="26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7" d="100"/>
          <a:sy n="47" d="100"/>
        </p:scale>
        <p:origin x="16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0586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91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6230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5355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006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621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600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223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24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753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1393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EB9C8-07D6-4E11-9317-0F4E429C2B1E}" type="datetimeFigureOut">
              <a:rPr lang="en-GB" smtClean="0"/>
              <a:t>09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2EFE3-0F48-4500-8E1B-0FEC0023B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399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290" y="0"/>
            <a:ext cx="771742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571500"/>
            <a:ext cx="223729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1a: Sensitivity analysis comparing the model discrimination (AUROC) in men and women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80891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949" y="0"/>
            <a:ext cx="7726101" cy="685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949" y="0"/>
            <a:ext cx="7726101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571500"/>
            <a:ext cx="223729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1b: Sensitivity analysis comparing the model discrimination (AUROC) in the whole cohort and the white-only cohort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156645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3714" y="0"/>
            <a:ext cx="6164572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97180" y="571500"/>
            <a:ext cx="223729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1c: Sensitivity analysis comparing the model discrimination (AUROC) in the whole cohort and cohorts excluding individuals with multiple close relatives and individuals with any 3</a:t>
            </a:r>
            <a:r>
              <a:rPr lang="en-GB" baseline="30000" dirty="0" smtClean="0"/>
              <a:t>rd</a:t>
            </a:r>
            <a:r>
              <a:rPr lang="en-GB" dirty="0" smtClean="0"/>
              <a:t> degree relative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9537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290" y="0"/>
            <a:ext cx="771742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571500"/>
            <a:ext cx="223729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1a: Sensitivity analysis comparing the model discrimination (AUROC) in the primary analysis, to that in a cohort using only individuals with no missing data for any of the model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96753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555480" y="612743"/>
            <a:ext cx="22372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2a: Calibration plots for GWAS models.</a:t>
            </a:r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247" y="496136"/>
            <a:ext cx="8876190" cy="6447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89273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555480" y="612743"/>
            <a:ext cx="22372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2b: Calibration plots for causal gene models.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262" y="612743"/>
            <a:ext cx="8161905" cy="59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27002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555480" y="612743"/>
            <a:ext cx="22372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2c: Calibration plots for mixed genetic and phenotypic models.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484" y="420357"/>
            <a:ext cx="8780952" cy="6266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26228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056" y="0"/>
            <a:ext cx="4699888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555480" y="612743"/>
            <a:ext cx="22372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3: Selection process of UKB cohort for primary analysi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62607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148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h Harrison</dc:creator>
  <cp:lastModifiedBy>Hannah Harrison</cp:lastModifiedBy>
  <cp:revision>7</cp:revision>
  <dcterms:created xsi:type="dcterms:W3CDTF">2022-01-08T13:21:53Z</dcterms:created>
  <dcterms:modified xsi:type="dcterms:W3CDTF">2022-02-09T13:43:42Z</dcterms:modified>
</cp:coreProperties>
</file>